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sldIdLst>
    <p:sldId id="257" r:id="rId5"/>
    <p:sldId id="27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AA00516-3988-4D00-8F3D-4F516271F017}" v="1" dt="2022-06-18T05:51:36.91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8394" autoAdjust="0"/>
  </p:normalViewPr>
  <p:slideViewPr>
    <p:cSldViewPr snapToGrid="0">
      <p:cViewPr>
        <p:scale>
          <a:sx n="60" d="100"/>
          <a:sy n="60" d="100"/>
        </p:scale>
        <p:origin x="840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-154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ardette Valmonte" userId="73850557-bb01-48c8-887d-e53624130e0c" providerId="ADAL" clId="{EAA00516-3988-4D00-8F3D-4F516271F017}"/>
    <pc:docChg chg="delSld modSld">
      <pc:chgData name="Gardette Valmonte" userId="73850557-bb01-48c8-887d-e53624130e0c" providerId="ADAL" clId="{EAA00516-3988-4D00-8F3D-4F516271F017}" dt="2022-06-18T05:53:14.728" v="54" actId="123"/>
      <pc:docMkLst>
        <pc:docMk/>
      </pc:docMkLst>
      <pc:sldChg chg="del">
        <pc:chgData name="Gardette Valmonte" userId="73850557-bb01-48c8-887d-e53624130e0c" providerId="ADAL" clId="{EAA00516-3988-4D00-8F3D-4F516271F017}" dt="2022-06-18T05:32:43.199" v="2" actId="47"/>
        <pc:sldMkLst>
          <pc:docMk/>
          <pc:sldMk cId="3890376444" sldId="256"/>
        </pc:sldMkLst>
      </pc:sldChg>
      <pc:sldChg chg="modSp mod">
        <pc:chgData name="Gardette Valmonte" userId="73850557-bb01-48c8-887d-e53624130e0c" providerId="ADAL" clId="{EAA00516-3988-4D00-8F3D-4F516271F017}" dt="2022-06-18T05:53:14.728" v="54" actId="123"/>
        <pc:sldMkLst>
          <pc:docMk/>
          <pc:sldMk cId="543474018" sldId="257"/>
        </pc:sldMkLst>
        <pc:spChg chg="mod">
          <ac:chgData name="Gardette Valmonte" userId="73850557-bb01-48c8-887d-e53624130e0c" providerId="ADAL" clId="{EAA00516-3988-4D00-8F3D-4F516271F017}" dt="2022-06-18T05:53:06.676" v="52" actId="1076"/>
          <ac:spMkLst>
            <pc:docMk/>
            <pc:sldMk cId="543474018" sldId="257"/>
            <ac:spMk id="85" creationId="{FAF0F0DB-91F5-C67F-3004-7A09E695DC0A}"/>
          </ac:spMkLst>
        </pc:spChg>
        <pc:spChg chg="mod">
          <ac:chgData name="Gardette Valmonte" userId="73850557-bb01-48c8-887d-e53624130e0c" providerId="ADAL" clId="{EAA00516-3988-4D00-8F3D-4F516271F017}" dt="2022-06-18T05:53:14.728" v="54" actId="123"/>
          <ac:spMkLst>
            <pc:docMk/>
            <pc:sldMk cId="543474018" sldId="257"/>
            <ac:spMk id="91" creationId="{4825D4A1-0A0F-D07F-FC18-1AB6BF649522}"/>
          </ac:spMkLst>
        </pc:spChg>
        <pc:spChg chg="mod">
          <ac:chgData name="Gardette Valmonte" userId="73850557-bb01-48c8-887d-e53624130e0c" providerId="ADAL" clId="{EAA00516-3988-4D00-8F3D-4F516271F017}" dt="2022-06-18T05:53:06.676" v="52" actId="1076"/>
          <ac:spMkLst>
            <pc:docMk/>
            <pc:sldMk cId="543474018" sldId="257"/>
            <ac:spMk id="101" creationId="{01A34369-38C9-62B8-277B-39C637190F8F}"/>
          </ac:spMkLst>
        </pc:spChg>
        <pc:spChg chg="mod">
          <ac:chgData name="Gardette Valmonte" userId="73850557-bb01-48c8-887d-e53624130e0c" providerId="ADAL" clId="{EAA00516-3988-4D00-8F3D-4F516271F017}" dt="2022-06-18T05:53:06.676" v="52" actId="1076"/>
          <ac:spMkLst>
            <pc:docMk/>
            <pc:sldMk cId="543474018" sldId="257"/>
            <ac:spMk id="102" creationId="{E9070E61-61FA-A9DE-00CB-449E0DF864BC}"/>
          </ac:spMkLst>
        </pc:spChg>
        <pc:grpChg chg="mod">
          <ac:chgData name="Gardette Valmonte" userId="73850557-bb01-48c8-887d-e53624130e0c" providerId="ADAL" clId="{EAA00516-3988-4D00-8F3D-4F516271F017}" dt="2022-06-18T05:53:06.676" v="52" actId="1076"/>
          <ac:grpSpMkLst>
            <pc:docMk/>
            <pc:sldMk cId="543474018" sldId="257"/>
            <ac:grpSpMk id="98" creationId="{E1CC728B-C446-6A28-BA49-7DCE11DCCB07}"/>
          </ac:grpSpMkLst>
        </pc:grpChg>
        <pc:graphicFrameChg chg="mod">
          <ac:chgData name="Gardette Valmonte" userId="73850557-bb01-48c8-887d-e53624130e0c" providerId="ADAL" clId="{EAA00516-3988-4D00-8F3D-4F516271F017}" dt="2022-06-18T05:53:06.676" v="52" actId="1076"/>
          <ac:graphicFrameMkLst>
            <pc:docMk/>
            <pc:sldMk cId="543474018" sldId="257"/>
            <ac:graphicFrameMk id="89" creationId="{E012CDA6-018A-7170-D69D-E67F98DAC326}"/>
          </ac:graphicFrameMkLst>
        </pc:graphicFrameChg>
        <pc:picChg chg="mod">
          <ac:chgData name="Gardette Valmonte" userId="73850557-bb01-48c8-887d-e53624130e0c" providerId="ADAL" clId="{EAA00516-3988-4D00-8F3D-4F516271F017}" dt="2022-06-18T05:53:06.676" v="52" actId="1076"/>
          <ac:picMkLst>
            <pc:docMk/>
            <pc:sldMk cId="543474018" sldId="257"/>
            <ac:picMk id="4" creationId="{ED5C701E-D6F3-8C73-652D-42815508A404}"/>
          </ac:picMkLst>
        </pc:picChg>
      </pc:sldChg>
      <pc:sldChg chg="del">
        <pc:chgData name="Gardette Valmonte" userId="73850557-bb01-48c8-887d-e53624130e0c" providerId="ADAL" clId="{EAA00516-3988-4D00-8F3D-4F516271F017}" dt="2022-06-18T05:32:42.230" v="1" actId="47"/>
        <pc:sldMkLst>
          <pc:docMk/>
          <pc:sldMk cId="4031989904" sldId="264"/>
        </pc:sldMkLst>
      </pc:sldChg>
      <pc:sldChg chg="del">
        <pc:chgData name="Gardette Valmonte" userId="73850557-bb01-48c8-887d-e53624130e0c" providerId="ADAL" clId="{EAA00516-3988-4D00-8F3D-4F516271F017}" dt="2022-06-18T05:32:41.533" v="0" actId="47"/>
        <pc:sldMkLst>
          <pc:docMk/>
          <pc:sldMk cId="2729678998" sldId="272"/>
        </pc:sldMkLst>
      </pc:sldChg>
      <pc:sldChg chg="addSp modSp mod">
        <pc:chgData name="Gardette Valmonte" userId="73850557-bb01-48c8-887d-e53624130e0c" providerId="ADAL" clId="{EAA00516-3988-4D00-8F3D-4F516271F017}" dt="2022-06-18T05:52:42.365" v="51" actId="14100"/>
        <pc:sldMkLst>
          <pc:docMk/>
          <pc:sldMk cId="2288281434" sldId="274"/>
        </pc:sldMkLst>
        <pc:spChg chg="add mod">
          <ac:chgData name="Gardette Valmonte" userId="73850557-bb01-48c8-887d-e53624130e0c" providerId="ADAL" clId="{EAA00516-3988-4D00-8F3D-4F516271F017}" dt="2022-06-18T05:52:42.365" v="51" actId="14100"/>
          <ac:spMkLst>
            <pc:docMk/>
            <pc:sldMk cId="2288281434" sldId="274"/>
            <ac:spMk id="2" creationId="{E72C95A1-CD1C-54D2-B423-A1FB5CA789F8}"/>
          </ac:spMkLst>
        </pc:spChg>
        <pc:grpChg chg="mod">
          <ac:chgData name="Gardette Valmonte" userId="73850557-bb01-48c8-887d-e53624130e0c" providerId="ADAL" clId="{EAA00516-3988-4D00-8F3D-4F516271F017}" dt="2022-06-18T05:32:58.583" v="4" actId="1076"/>
          <ac:grpSpMkLst>
            <pc:docMk/>
            <pc:sldMk cId="2288281434" sldId="274"/>
            <ac:grpSpMk id="8" creationId="{4ACBD1D2-733F-E5E2-462D-135EB1E5A073}"/>
          </ac:grpSpMkLst>
        </pc:gr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4982F6-E519-461D-9E54-BB52E73DF553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E2E1F5-4846-4BC1-832E-6933DEC455E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559261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6069BA-5E0A-9BFD-8B0B-AE60F2D8F5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5886518-861E-F268-2F74-49B1A689B3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0CF0FF-BE2D-8057-F4E8-7C021DCCD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C9B35-53C0-4590-8821-5FD53DB0A1CB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160AAE-389D-763F-4FF1-7B007CBAE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A1B4B4-D2C7-995D-1CB1-4EF1A8CFFE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C82A6-609E-4E28-BA8E-4EB20746F19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090224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BE37DE-4192-FA9A-B19E-03BD5518E5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FED3B6-CFE1-1CE3-BAFB-8C49C6F47C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5C0913-F1A4-3AE2-CEDA-1A92293B03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C9B35-53C0-4590-8821-5FD53DB0A1CB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F775AA-D507-E7D1-E419-8EF3C1DBA2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37B8FB-94F2-25A4-F832-9316E3FE8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C82A6-609E-4E28-BA8E-4EB20746F19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699966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F953A70-076B-AF0D-F699-BA9FAAABBF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4FDF62-3195-88C5-5ED2-C3AAAC4FF3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E32F5A-4C86-4D7D-9BB6-B7DBC7B6F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C9B35-53C0-4590-8821-5FD53DB0A1CB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0E6776-F439-1F8C-DE20-2C37A5C3E5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575477-4AB1-21D3-EE0E-B4A327401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C82A6-609E-4E28-BA8E-4EB20746F19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492191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F40CCD-90F3-1204-11AD-7CF2ADDB91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6A8BFC-D5EB-1EEF-27F7-03469DC48E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FB44F2-AF79-8F99-1121-1690E69B7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C9B35-53C0-4590-8821-5FD53DB0A1CB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8AB82A-8D73-F242-CD14-6B32ABB39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0555F7-A644-0629-F2F1-ED0F2A0BD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C82A6-609E-4E28-BA8E-4EB20746F19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803664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70A5B-B640-ED9C-0E55-AFFCCADBBA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A26ADE-1552-F605-B4D1-348484677C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F41DE6-A0FB-6F62-6352-14CACA2D2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C9B35-53C0-4590-8821-5FD53DB0A1CB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65CA2C-4364-4149-C1BC-913277774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92ACCF-7778-98D3-DFE2-DEFE51E0F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C82A6-609E-4E28-BA8E-4EB20746F19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286438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C0ECD4-6B3F-3EFB-A13B-C6174220A0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50F441-4D4A-B5C4-679F-999AFB9333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E53FC4-E44B-5554-76A6-B9B7E2A452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6B9D57-982B-E2C6-FC14-E2CED2CF9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C9B35-53C0-4590-8821-5FD53DB0A1CB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25DCD3-E7A1-35D0-C89C-269244445A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E1CCD7-324F-6E71-D5F9-32B0B5E47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C82A6-609E-4E28-BA8E-4EB20746F19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71832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AD0E95-1757-6152-F25C-780FF4769B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DD0608-9CFE-1FAB-DF07-3C2BD7C2EC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4AF75F-5172-FA55-2E49-10CFAFBA3B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0683E5-AA68-5428-CCD2-DD6EC3AA41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5179F4-8478-4598-1B56-CF172EB60A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C057534-CF41-D5E4-C09F-E337765B1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C9B35-53C0-4590-8821-5FD53DB0A1CB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8C7A8C4-1A8F-6306-B94C-942CE75F3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8B5528-370F-0055-AA85-35BC228E3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C82A6-609E-4E28-BA8E-4EB20746F19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8823348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FDF328-730A-1E89-4410-3169A91F94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F9A0A2-C0E0-D373-AD9E-B1961285E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C9B35-53C0-4590-8821-5FD53DB0A1CB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92A7450-76E8-EEAC-6E0A-4788F5F60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7AAD91-B64C-4AD6-F6FC-FC85AFFB21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C82A6-609E-4E28-BA8E-4EB20746F19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554069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1C372F7-7C77-F4B3-F88D-70AA531366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C9B35-53C0-4590-8821-5FD53DB0A1CB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7D4DD7-7A41-DBD2-9DA6-E65536786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A96574-8422-C0B3-5763-EE3545FF34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C82A6-609E-4E28-BA8E-4EB20746F19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88420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8DA76B-A863-3440-A10C-F5ECCCEB9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6D566F-8746-DBD0-D4AC-D0E57F206A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B59D17B-6646-6319-A290-7D9923666E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BFE7C7-BBCD-D2B4-EDC3-55CE6154D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C9B35-53C0-4590-8821-5FD53DB0A1CB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536B01-11AC-CF78-5D31-1DDED09D8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1E3665-5F9D-6F0F-13EB-D67FD93DF8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C82A6-609E-4E28-BA8E-4EB20746F19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893823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6892DB-B804-62A7-05DF-9247629CD6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0D94FF2-2C40-70A2-E16C-F396D1CF7B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2663E0-1219-E3F1-F1E1-69B809DB79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4A73F8-DF20-E798-ACA3-3658054B8B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C9B35-53C0-4590-8821-5FD53DB0A1CB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D00FAD-80B6-1A72-8FD6-402B25410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ED5031-C2BE-74B0-7F65-146BBD948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C82A6-609E-4E28-BA8E-4EB20746F19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197765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A8EADD-6C14-8543-A2F6-B366B21989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CED6DF-DF7A-EB0F-8E39-138FAB2150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353383-7D26-9E4A-0F43-699EEEED53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FC9B35-53C0-4590-8821-5FD53DB0A1CB}" type="datetimeFigureOut">
              <a:rPr lang="en-NZ" smtClean="0"/>
              <a:t>18/06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3A3AE8-B15A-4F4F-1FAD-7D1AFF6AC1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7CB193-6187-F994-1162-DAFE4B35F5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C82A6-609E-4E28-BA8E-4EB20746F19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81055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ED5C701E-D6F3-8C73-652D-42815508A40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80" t="723" r="6211" b="82235"/>
          <a:stretch/>
        </p:blipFill>
        <p:spPr bwMode="auto">
          <a:xfrm>
            <a:off x="1643582" y="120386"/>
            <a:ext cx="6116823" cy="1640394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TextBox 90">
            <a:extLst>
              <a:ext uri="{FF2B5EF4-FFF2-40B4-BE49-F238E27FC236}">
                <a16:creationId xmlns:a16="http://schemas.microsoft.com/office/drawing/2014/main" id="{4825D4A1-0A0F-D07F-FC18-1AB6BF649522}"/>
              </a:ext>
            </a:extLst>
          </p:cNvPr>
          <p:cNvSpPr txBox="1"/>
          <p:nvPr/>
        </p:nvSpPr>
        <p:spPr>
          <a:xfrm>
            <a:off x="7720468" y="1618599"/>
            <a:ext cx="437621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NZ" sz="1400" b="1" dirty="0">
                <a:latin typeface="Palatino Linotype" panose="02040502050505030304" pitchFamily="18" charset="0"/>
              </a:rPr>
              <a:t>Figure S1. </a:t>
            </a:r>
            <a:r>
              <a:rPr lang="en-NZ" sz="14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T-PCR amplification of G gene from LNYV-infected lettuce RNA samples. (</a:t>
            </a:r>
            <a:r>
              <a:rPr lang="en-NZ" sz="14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NZ" sz="14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Position of primers relative to the G gene (dark green) within LNYV. Primer positions are indicated by blue arrows. Expected PCR products indicated by light green bars.; (</a:t>
            </a:r>
            <a:r>
              <a:rPr lang="en-NZ" sz="14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NZ" sz="14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garose gel showing expected PCR products for indicated primer combinations on LNYV-SI sample RPE2, and SII sample RPE3.; (</a:t>
            </a:r>
            <a:r>
              <a:rPr lang="en-NZ" sz="14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NZ" sz="14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Sequence and melting temperature for each primer together with expected PCR product sizes for the indicated primer combinations.  </a:t>
            </a:r>
          </a:p>
          <a:p>
            <a:pPr algn="just"/>
            <a:endParaRPr lang="en-NZ" sz="1400" dirty="0">
              <a:latin typeface="Palatino Linotype" panose="02040502050505030304" pitchFamily="18" charset="0"/>
            </a:endParaRPr>
          </a:p>
        </p:txBody>
      </p:sp>
      <p:grpSp>
        <p:nvGrpSpPr>
          <p:cNvPr id="98" name="Group 97">
            <a:extLst>
              <a:ext uri="{FF2B5EF4-FFF2-40B4-BE49-F238E27FC236}">
                <a16:creationId xmlns:a16="http://schemas.microsoft.com/office/drawing/2014/main" id="{E1CC728B-C446-6A28-BA49-7DCE11DCCB07}"/>
              </a:ext>
            </a:extLst>
          </p:cNvPr>
          <p:cNvGrpSpPr/>
          <p:nvPr/>
        </p:nvGrpSpPr>
        <p:grpSpPr>
          <a:xfrm>
            <a:off x="2841802" y="1975925"/>
            <a:ext cx="3535742" cy="2057120"/>
            <a:chOff x="3350434" y="3187336"/>
            <a:chExt cx="3535742" cy="2057120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7ECD4F9-E212-7269-9B89-CED32D09127B}"/>
                </a:ext>
              </a:extLst>
            </p:cNvPr>
            <p:cNvSpPr txBox="1"/>
            <p:nvPr/>
          </p:nvSpPr>
          <p:spPr>
            <a:xfrm>
              <a:off x="4158606" y="3654861"/>
              <a:ext cx="469087" cy="274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dirty="0"/>
                <a:t>P6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5EEC563-0D3D-D0F8-4EF0-69DA4F60D07C}"/>
                </a:ext>
              </a:extLst>
            </p:cNvPr>
            <p:cNvSpPr txBox="1"/>
            <p:nvPr/>
          </p:nvSpPr>
          <p:spPr>
            <a:xfrm>
              <a:off x="4360903" y="3658029"/>
              <a:ext cx="469087" cy="274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dirty="0"/>
                <a:t>P6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632FD37-A902-4B1F-51CF-7704EC129262}"/>
                </a:ext>
              </a:extLst>
            </p:cNvPr>
            <p:cNvSpPr txBox="1"/>
            <p:nvPr/>
          </p:nvSpPr>
          <p:spPr>
            <a:xfrm>
              <a:off x="4581147" y="3656008"/>
              <a:ext cx="469087" cy="274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dirty="0"/>
                <a:t>P8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DD143A1-940B-4197-B27D-4EF9D226100A}"/>
                </a:ext>
              </a:extLst>
            </p:cNvPr>
            <p:cNvSpPr txBox="1"/>
            <p:nvPr/>
          </p:nvSpPr>
          <p:spPr>
            <a:xfrm>
              <a:off x="4791922" y="3653986"/>
              <a:ext cx="46908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dirty="0"/>
                <a:t>P8    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B8BAF43-12A4-6648-585A-1B18CC25485E}"/>
                </a:ext>
              </a:extLst>
            </p:cNvPr>
            <p:cNvSpPr txBox="1"/>
            <p:nvPr/>
          </p:nvSpPr>
          <p:spPr>
            <a:xfrm>
              <a:off x="5000627" y="3655208"/>
              <a:ext cx="469087" cy="274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dirty="0"/>
                <a:t>P6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81B90FD-2179-BF35-4FCA-91AA7271B196}"/>
                </a:ext>
              </a:extLst>
            </p:cNvPr>
            <p:cNvSpPr txBox="1"/>
            <p:nvPr/>
          </p:nvSpPr>
          <p:spPr>
            <a:xfrm>
              <a:off x="5195065" y="3654429"/>
              <a:ext cx="469087" cy="274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dirty="0"/>
                <a:t>P6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7786B754-CF1B-6A22-84B0-021CCFD3A07F}"/>
                </a:ext>
              </a:extLst>
            </p:cNvPr>
            <p:cNvSpPr txBox="1"/>
            <p:nvPr/>
          </p:nvSpPr>
          <p:spPr>
            <a:xfrm>
              <a:off x="4180069" y="3387468"/>
              <a:ext cx="326897" cy="3116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100" dirty="0"/>
                <a:t>+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9AA5BADC-ACE6-3386-BB50-6252229A91B9}"/>
                </a:ext>
              </a:extLst>
            </p:cNvPr>
            <p:cNvSpPr txBox="1"/>
            <p:nvPr/>
          </p:nvSpPr>
          <p:spPr>
            <a:xfrm>
              <a:off x="4606602" y="3387467"/>
              <a:ext cx="326897" cy="3116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100" dirty="0"/>
                <a:t>+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305990F5-2DDE-71B7-9650-F73C580716F5}"/>
                </a:ext>
              </a:extLst>
            </p:cNvPr>
            <p:cNvSpPr txBox="1"/>
            <p:nvPr/>
          </p:nvSpPr>
          <p:spPr>
            <a:xfrm>
              <a:off x="5022553" y="3386338"/>
              <a:ext cx="326897" cy="3116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100" dirty="0"/>
                <a:t>+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69ECAF2E-3C26-73A6-FD0E-3A936A23981E}"/>
                </a:ext>
              </a:extLst>
            </p:cNvPr>
            <p:cNvSpPr txBox="1"/>
            <p:nvPr/>
          </p:nvSpPr>
          <p:spPr>
            <a:xfrm>
              <a:off x="4399560" y="3381142"/>
              <a:ext cx="291991" cy="3116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100" dirty="0"/>
                <a:t>-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4275AD2F-519B-DDB7-313B-08ABA5E77D08}"/>
                </a:ext>
              </a:extLst>
            </p:cNvPr>
            <p:cNvSpPr txBox="1"/>
            <p:nvPr/>
          </p:nvSpPr>
          <p:spPr>
            <a:xfrm>
              <a:off x="4829466" y="3381142"/>
              <a:ext cx="291991" cy="3116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100" dirty="0"/>
                <a:t>-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8E98145A-7298-71A3-2BDB-52122DF7F709}"/>
                </a:ext>
              </a:extLst>
            </p:cNvPr>
            <p:cNvSpPr txBox="1"/>
            <p:nvPr/>
          </p:nvSpPr>
          <p:spPr>
            <a:xfrm>
              <a:off x="5234722" y="3382275"/>
              <a:ext cx="291991" cy="3116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100" dirty="0"/>
                <a:t>-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7AB288EB-C30F-B125-4BEC-F222BA703377}"/>
                </a:ext>
              </a:extLst>
            </p:cNvPr>
            <p:cNvSpPr txBox="1"/>
            <p:nvPr/>
          </p:nvSpPr>
          <p:spPr>
            <a:xfrm>
              <a:off x="4157813" y="3541252"/>
              <a:ext cx="386445" cy="2749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900" dirty="0"/>
                <a:t>P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F438FD8-8129-0420-E16C-445A87FDB430}"/>
                </a:ext>
              </a:extLst>
            </p:cNvPr>
            <p:cNvSpPr txBox="1"/>
            <p:nvPr/>
          </p:nvSpPr>
          <p:spPr>
            <a:xfrm>
              <a:off x="4367095" y="3539907"/>
              <a:ext cx="386445" cy="2749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900" dirty="0"/>
                <a:t>P5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08933001-96D1-DDF4-2278-9CB60938C993}"/>
                </a:ext>
              </a:extLst>
            </p:cNvPr>
            <p:cNvSpPr txBox="1"/>
            <p:nvPr/>
          </p:nvSpPr>
          <p:spPr>
            <a:xfrm>
              <a:off x="4584088" y="3538568"/>
              <a:ext cx="386445" cy="2749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900" dirty="0"/>
                <a:t>P5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8BE9020-349C-AA69-DC41-8BFAC568A3A0}"/>
                </a:ext>
              </a:extLst>
            </p:cNvPr>
            <p:cNvSpPr txBox="1"/>
            <p:nvPr/>
          </p:nvSpPr>
          <p:spPr>
            <a:xfrm>
              <a:off x="4798937" y="3543551"/>
              <a:ext cx="386445" cy="2749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900" dirty="0"/>
                <a:t>P5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B7E8BA68-BEE4-DC7C-92D1-1AED495F2F16}"/>
                </a:ext>
              </a:extLst>
            </p:cNvPr>
            <p:cNvSpPr txBox="1"/>
            <p:nvPr/>
          </p:nvSpPr>
          <p:spPr>
            <a:xfrm>
              <a:off x="5004721" y="3542210"/>
              <a:ext cx="386445" cy="2749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900" dirty="0"/>
                <a:t>P7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FB4BAA92-8412-EA40-419C-6126EEAE1933}"/>
                </a:ext>
              </a:extLst>
            </p:cNvPr>
            <p:cNvSpPr txBox="1"/>
            <p:nvPr/>
          </p:nvSpPr>
          <p:spPr>
            <a:xfrm>
              <a:off x="5195985" y="3539836"/>
              <a:ext cx="386445" cy="2749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900" dirty="0"/>
                <a:t>P7</a:t>
              </a:r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3A3F4006-CC3D-4036-D443-18D331B3316C}"/>
                </a:ext>
              </a:extLst>
            </p:cNvPr>
            <p:cNvCxnSpPr>
              <a:cxnSpLocks/>
              <a:endCxn id="84" idx="0"/>
            </p:cNvCxnSpPr>
            <p:nvPr/>
          </p:nvCxnSpPr>
          <p:spPr>
            <a:xfrm>
              <a:off x="4225925" y="3382275"/>
              <a:ext cx="11547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4FC85BBE-599B-B608-6C85-B49597C99637}"/>
                </a:ext>
              </a:extLst>
            </p:cNvPr>
            <p:cNvSpPr txBox="1"/>
            <p:nvPr/>
          </p:nvSpPr>
          <p:spPr>
            <a:xfrm>
              <a:off x="4578539" y="3187336"/>
              <a:ext cx="7617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900" dirty="0"/>
                <a:t>NZ-RPE2 (SI)</a:t>
              </a:r>
            </a:p>
          </p:txBody>
        </p: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3E6C0584-D1D5-E45E-5DCE-22E78AA18951}"/>
                </a:ext>
              </a:extLst>
            </p:cNvPr>
            <p:cNvGrpSpPr/>
            <p:nvPr/>
          </p:nvGrpSpPr>
          <p:grpSpPr>
            <a:xfrm>
              <a:off x="5420613" y="3189270"/>
              <a:ext cx="1465563" cy="744710"/>
              <a:chOff x="5832935" y="3189270"/>
              <a:chExt cx="1465563" cy="744710"/>
            </a:xfrm>
          </p:grpSpPr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AAB2575F-9CEF-8101-3460-8A85F5187358}"/>
                  </a:ext>
                </a:extLst>
              </p:cNvPr>
              <p:cNvSpPr txBox="1"/>
              <p:nvPr/>
            </p:nvSpPr>
            <p:spPr>
              <a:xfrm>
                <a:off x="5832936" y="3657874"/>
                <a:ext cx="386445" cy="274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900" dirty="0"/>
                  <a:t>P2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8BD38EA8-7354-1A67-F595-19ECCB13A81B}"/>
                  </a:ext>
                </a:extLst>
              </p:cNvPr>
              <p:cNvSpPr txBox="1"/>
              <p:nvPr/>
            </p:nvSpPr>
            <p:spPr>
              <a:xfrm>
                <a:off x="6047475" y="3654708"/>
                <a:ext cx="386445" cy="274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900" dirty="0"/>
                  <a:t>P2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3BE4F66D-FCEB-9532-6059-18BC86CE37F1}"/>
                  </a:ext>
                </a:extLst>
              </p:cNvPr>
              <p:cNvSpPr txBox="1"/>
              <p:nvPr/>
            </p:nvSpPr>
            <p:spPr>
              <a:xfrm>
                <a:off x="6255480" y="3659021"/>
                <a:ext cx="386445" cy="274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900" dirty="0"/>
                  <a:t>P4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B60ACAB7-DA81-DFA8-E9D7-12941FB63006}"/>
                  </a:ext>
                </a:extLst>
              </p:cNvPr>
              <p:cNvSpPr txBox="1"/>
              <p:nvPr/>
            </p:nvSpPr>
            <p:spPr>
              <a:xfrm>
                <a:off x="6466666" y="3657000"/>
                <a:ext cx="386445" cy="274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900" dirty="0"/>
                  <a:t>P4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140CF8D7-528D-54D4-B9D4-E168B57910CF}"/>
                  </a:ext>
                </a:extLst>
              </p:cNvPr>
              <p:cNvSpPr txBox="1"/>
              <p:nvPr/>
            </p:nvSpPr>
            <p:spPr>
              <a:xfrm>
                <a:off x="6686742" y="3658220"/>
                <a:ext cx="386445" cy="274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900" dirty="0"/>
                  <a:t>P2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8FA414A8-246F-9839-AB55-A8F1FAF361FB}"/>
                  </a:ext>
                </a:extLst>
              </p:cNvPr>
              <p:cNvSpPr txBox="1"/>
              <p:nvPr/>
            </p:nvSpPr>
            <p:spPr>
              <a:xfrm>
                <a:off x="6912053" y="3657443"/>
                <a:ext cx="386445" cy="274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900" dirty="0"/>
                  <a:t>P2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4538D256-C9C3-B9C0-DD90-2C46ADD707DB}"/>
                  </a:ext>
                </a:extLst>
              </p:cNvPr>
              <p:cNvSpPr txBox="1"/>
              <p:nvPr/>
            </p:nvSpPr>
            <p:spPr>
              <a:xfrm>
                <a:off x="5857589" y="3385207"/>
                <a:ext cx="326897" cy="3116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/>
                  <a:t>+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4012990D-D3E6-D2D8-EF16-6E8E9F748482}"/>
                  </a:ext>
                </a:extLst>
              </p:cNvPr>
              <p:cNvSpPr txBox="1"/>
              <p:nvPr/>
            </p:nvSpPr>
            <p:spPr>
              <a:xfrm>
                <a:off x="6284399" y="3385206"/>
                <a:ext cx="326897" cy="3116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/>
                  <a:t>+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863F6049-3EDA-1E43-E751-0C8BE3764510}"/>
                  </a:ext>
                </a:extLst>
              </p:cNvPr>
              <p:cNvSpPr txBox="1"/>
              <p:nvPr/>
            </p:nvSpPr>
            <p:spPr>
              <a:xfrm>
                <a:off x="6710518" y="3388141"/>
                <a:ext cx="326897" cy="3116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/>
                  <a:t>+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DF2DA360-B4B3-F2B2-8727-C84F467B9095}"/>
                  </a:ext>
                </a:extLst>
              </p:cNvPr>
              <p:cNvSpPr txBox="1"/>
              <p:nvPr/>
            </p:nvSpPr>
            <p:spPr>
              <a:xfrm>
                <a:off x="6094824" y="3383408"/>
                <a:ext cx="291991" cy="3116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/>
                  <a:t>-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2D257F78-38CA-B0C1-68CE-32AE342CF16D}"/>
                  </a:ext>
                </a:extLst>
              </p:cNvPr>
              <p:cNvSpPr txBox="1"/>
              <p:nvPr/>
            </p:nvSpPr>
            <p:spPr>
              <a:xfrm>
                <a:off x="6506142" y="3383408"/>
                <a:ext cx="291991" cy="3116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/>
                  <a:t>-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EED651AD-C02A-A8C2-CC96-DE7E14C6D232}"/>
                  </a:ext>
                </a:extLst>
              </p:cNvPr>
              <p:cNvSpPr txBox="1"/>
              <p:nvPr/>
            </p:nvSpPr>
            <p:spPr>
              <a:xfrm>
                <a:off x="6942822" y="3381142"/>
                <a:ext cx="291991" cy="3116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/>
                  <a:t>-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4B1DD138-E3D3-7FBF-29F3-BC67506DE828}"/>
                  </a:ext>
                </a:extLst>
              </p:cNvPr>
              <p:cNvSpPr txBox="1"/>
              <p:nvPr/>
            </p:nvSpPr>
            <p:spPr>
              <a:xfrm>
                <a:off x="5832935" y="3543935"/>
                <a:ext cx="386445" cy="274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900" dirty="0"/>
                  <a:t>P1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7FF58708-3110-A384-7A00-ACF37DD05BD0}"/>
                  </a:ext>
                </a:extLst>
              </p:cNvPr>
              <p:cNvSpPr txBox="1"/>
              <p:nvPr/>
            </p:nvSpPr>
            <p:spPr>
              <a:xfrm>
                <a:off x="6255484" y="3541907"/>
                <a:ext cx="386445" cy="274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900" dirty="0"/>
                  <a:t>P1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377B00E2-1B40-70A5-B86A-443801AE84BD}"/>
                  </a:ext>
                </a:extLst>
              </p:cNvPr>
              <p:cNvSpPr txBox="1"/>
              <p:nvPr/>
            </p:nvSpPr>
            <p:spPr>
              <a:xfrm>
                <a:off x="6686742" y="3541105"/>
                <a:ext cx="386445" cy="274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900" dirty="0"/>
                  <a:t>P3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015F9A2F-B755-7536-CADF-696FF6A7BB98}"/>
                  </a:ext>
                </a:extLst>
              </p:cNvPr>
              <p:cNvSpPr txBox="1"/>
              <p:nvPr/>
            </p:nvSpPr>
            <p:spPr>
              <a:xfrm>
                <a:off x="6039072" y="3538455"/>
                <a:ext cx="386445" cy="274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900" dirty="0"/>
                  <a:t>P1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9D14E967-BDAB-4345-DE89-69793A989BE9}"/>
                  </a:ext>
                </a:extLst>
              </p:cNvPr>
              <p:cNvSpPr txBox="1"/>
              <p:nvPr/>
            </p:nvSpPr>
            <p:spPr>
              <a:xfrm>
                <a:off x="6464839" y="3540747"/>
                <a:ext cx="386445" cy="274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900" dirty="0"/>
                  <a:t>P1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28F284E3-73BF-01D5-1438-B103EAD40060}"/>
                  </a:ext>
                </a:extLst>
              </p:cNvPr>
              <p:cNvSpPr txBox="1"/>
              <p:nvPr/>
            </p:nvSpPr>
            <p:spPr>
              <a:xfrm>
                <a:off x="6912053" y="3537833"/>
                <a:ext cx="386445" cy="274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900" dirty="0"/>
                  <a:t>P3</a:t>
                </a:r>
              </a:p>
            </p:txBody>
          </p:sp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4CBC90A4-19C3-E6DE-4A5D-E25DC4DD40B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03394" y="3382688"/>
                <a:ext cx="1233091" cy="12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CE49CADB-402E-5A31-F82A-4F1153850F80}"/>
                  </a:ext>
                </a:extLst>
              </p:cNvPr>
              <p:cNvSpPr txBox="1"/>
              <p:nvPr/>
            </p:nvSpPr>
            <p:spPr>
              <a:xfrm>
                <a:off x="6153711" y="3189270"/>
                <a:ext cx="8206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NZ" sz="900" dirty="0"/>
                  <a:t>NZ-RPE3 (SII)</a:t>
                </a:r>
              </a:p>
            </p:txBody>
          </p:sp>
        </p:grp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8FC2B913-220B-3343-7CD4-1BB9BAB33C2F}"/>
                </a:ext>
              </a:extLst>
            </p:cNvPr>
            <p:cNvSpPr txBox="1"/>
            <p:nvPr/>
          </p:nvSpPr>
          <p:spPr>
            <a:xfrm>
              <a:off x="3632598" y="3392046"/>
              <a:ext cx="937359" cy="274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dirty="0"/>
                <a:t>Template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EF59875-CB98-18A0-3C01-4CE1274983C2}"/>
                </a:ext>
              </a:extLst>
            </p:cNvPr>
            <p:cNvSpPr txBox="1"/>
            <p:nvPr/>
          </p:nvSpPr>
          <p:spPr>
            <a:xfrm>
              <a:off x="3350434" y="3526913"/>
              <a:ext cx="1323736" cy="2749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dirty="0"/>
                <a:t>Forward primer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BD8B1FE-FF6C-B95A-A7EC-E78A71ABE14B}"/>
                </a:ext>
              </a:extLst>
            </p:cNvPr>
            <p:cNvSpPr txBox="1"/>
            <p:nvPr/>
          </p:nvSpPr>
          <p:spPr>
            <a:xfrm>
              <a:off x="3364818" y="3647811"/>
              <a:ext cx="1323736" cy="2749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dirty="0"/>
                <a:t>Reverse primer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B175522-A6BF-EBCB-0869-762809AE587F}"/>
                </a:ext>
              </a:extLst>
            </p:cNvPr>
            <p:cNvSpPr txBox="1"/>
            <p:nvPr/>
          </p:nvSpPr>
          <p:spPr>
            <a:xfrm>
              <a:off x="3722986" y="3916885"/>
              <a:ext cx="499379" cy="2566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800" dirty="0"/>
                <a:t>300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BE19739-B9B6-7989-70F5-C5DC76C0013F}"/>
                </a:ext>
              </a:extLst>
            </p:cNvPr>
            <p:cNvSpPr txBox="1"/>
            <p:nvPr/>
          </p:nvSpPr>
          <p:spPr>
            <a:xfrm>
              <a:off x="3728601" y="4168838"/>
              <a:ext cx="499379" cy="2566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800" dirty="0"/>
                <a:t>2000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BA72751C-B127-E08A-6F8D-A74E3B958C0F}"/>
                </a:ext>
              </a:extLst>
            </p:cNvPr>
            <p:cNvSpPr txBox="1"/>
            <p:nvPr/>
          </p:nvSpPr>
          <p:spPr>
            <a:xfrm>
              <a:off x="3723530" y="4339444"/>
              <a:ext cx="499379" cy="2566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800" dirty="0"/>
                <a:t>1500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C639255-7594-748F-7C89-70538D5A2B2B}"/>
                </a:ext>
              </a:extLst>
            </p:cNvPr>
            <p:cNvSpPr txBox="1"/>
            <p:nvPr/>
          </p:nvSpPr>
          <p:spPr>
            <a:xfrm>
              <a:off x="3726248" y="4614348"/>
              <a:ext cx="499379" cy="2566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800" dirty="0"/>
                <a:t>1000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7753DAC-4876-B563-86B1-15203BE9E98C}"/>
                </a:ext>
              </a:extLst>
            </p:cNvPr>
            <p:cNvSpPr txBox="1"/>
            <p:nvPr/>
          </p:nvSpPr>
          <p:spPr>
            <a:xfrm>
              <a:off x="3775855" y="4689344"/>
              <a:ext cx="433672" cy="2566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800" dirty="0"/>
                <a:t>900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6840A26-6CE0-7DAC-C345-204C8F70A894}"/>
                </a:ext>
              </a:extLst>
            </p:cNvPr>
            <p:cNvSpPr txBox="1"/>
            <p:nvPr/>
          </p:nvSpPr>
          <p:spPr>
            <a:xfrm>
              <a:off x="3775069" y="4755735"/>
              <a:ext cx="433672" cy="2566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800" dirty="0"/>
                <a:t>800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981B49F5-7A7C-66E1-AB19-B4CE12A7A4D8}"/>
                </a:ext>
              </a:extLst>
            </p:cNvPr>
            <p:cNvSpPr txBox="1"/>
            <p:nvPr/>
          </p:nvSpPr>
          <p:spPr>
            <a:xfrm>
              <a:off x="3774282" y="4827736"/>
              <a:ext cx="433672" cy="2566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800" dirty="0"/>
                <a:t>700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83BBDC71-6D19-7DBB-4B4C-CEB9C759AF0E}"/>
                </a:ext>
              </a:extLst>
            </p:cNvPr>
            <p:cNvSpPr txBox="1"/>
            <p:nvPr/>
          </p:nvSpPr>
          <p:spPr>
            <a:xfrm>
              <a:off x="3775855" y="4894983"/>
              <a:ext cx="433672" cy="2566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800" dirty="0"/>
                <a:t>600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942085C6-F48A-9555-8EBC-604CD13C512F}"/>
                </a:ext>
              </a:extLst>
            </p:cNvPr>
            <p:cNvSpPr txBox="1"/>
            <p:nvPr/>
          </p:nvSpPr>
          <p:spPr>
            <a:xfrm>
              <a:off x="3776061" y="4987826"/>
              <a:ext cx="433672" cy="2566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800" dirty="0"/>
                <a:t>50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58982B7-2CEA-E735-A2FB-2FD4D6550030}"/>
                </a:ext>
              </a:extLst>
            </p:cNvPr>
            <p:cNvSpPr txBox="1"/>
            <p:nvPr/>
          </p:nvSpPr>
          <p:spPr>
            <a:xfrm>
              <a:off x="3821853" y="3802030"/>
              <a:ext cx="376177" cy="2566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800" dirty="0"/>
                <a:t>bp</a:t>
              </a:r>
            </a:p>
          </p:txBody>
        </p:sp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5480BE73-7CAA-247B-32CA-587E21898B7B}"/>
                </a:ext>
              </a:extLst>
            </p:cNvPr>
            <p:cNvGrpSpPr/>
            <p:nvPr/>
          </p:nvGrpSpPr>
          <p:grpSpPr>
            <a:xfrm>
              <a:off x="4030812" y="3863874"/>
              <a:ext cx="2820472" cy="1305897"/>
              <a:chOff x="7605432" y="4039858"/>
              <a:chExt cx="2820472" cy="1305897"/>
            </a:xfrm>
          </p:grpSpPr>
          <p:pic>
            <p:nvPicPr>
              <p:cNvPr id="92" name="Picture 91" descr="A picture containing text&#10;&#10;Description automatically generated">
                <a:extLst>
                  <a:ext uri="{FF2B5EF4-FFF2-40B4-BE49-F238E27FC236}">
                    <a16:creationId xmlns:a16="http://schemas.microsoft.com/office/drawing/2014/main" id="{C8690DDC-FF11-DF55-6DBE-001E72A4763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29" t="22932" r="78640" b="67833"/>
              <a:stretch/>
            </p:blipFill>
            <p:spPr bwMode="auto">
              <a:xfrm>
                <a:off x="7605432" y="4039858"/>
                <a:ext cx="1427956" cy="130589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93" name="Picture 92" descr="A picture containing text&#10;&#10;Description automatically generated">
                <a:extLst>
                  <a:ext uri="{FF2B5EF4-FFF2-40B4-BE49-F238E27FC236}">
                    <a16:creationId xmlns:a16="http://schemas.microsoft.com/office/drawing/2014/main" id="{D8D74002-148E-B921-5618-B1A3CED5637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839" t="22932" r="62484" b="67833"/>
              <a:stretch/>
            </p:blipFill>
            <p:spPr bwMode="auto">
              <a:xfrm>
                <a:off x="9026014" y="4039858"/>
                <a:ext cx="1399890" cy="1305897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</p:grpSp>
      <p:sp>
        <p:nvSpPr>
          <p:cNvPr id="101" name="TextBox 100">
            <a:extLst>
              <a:ext uri="{FF2B5EF4-FFF2-40B4-BE49-F238E27FC236}">
                <a16:creationId xmlns:a16="http://schemas.microsoft.com/office/drawing/2014/main" id="{01A34369-38C9-62B8-277B-39C637190F8F}"/>
              </a:ext>
            </a:extLst>
          </p:cNvPr>
          <p:cNvSpPr txBox="1"/>
          <p:nvPr/>
        </p:nvSpPr>
        <p:spPr>
          <a:xfrm>
            <a:off x="1140302" y="267652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A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E9070E61-61FA-A9DE-00CB-449E0DF864BC}"/>
              </a:ext>
            </a:extLst>
          </p:cNvPr>
          <p:cNvSpPr txBox="1"/>
          <p:nvPr/>
        </p:nvSpPr>
        <p:spPr>
          <a:xfrm>
            <a:off x="1140302" y="2029090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B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AF0F0DB-91F5-C67F-3004-7A09E695DC0A}"/>
              </a:ext>
            </a:extLst>
          </p:cNvPr>
          <p:cNvSpPr txBox="1"/>
          <p:nvPr/>
        </p:nvSpPr>
        <p:spPr>
          <a:xfrm>
            <a:off x="1143689" y="404022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C</a:t>
            </a:r>
          </a:p>
        </p:txBody>
      </p:sp>
      <p:graphicFrame>
        <p:nvGraphicFramePr>
          <p:cNvPr id="89" name="Table 88">
            <a:extLst>
              <a:ext uri="{FF2B5EF4-FFF2-40B4-BE49-F238E27FC236}">
                <a16:creationId xmlns:a16="http://schemas.microsoft.com/office/drawing/2014/main" id="{E012CDA6-018A-7170-D69D-E67F98DAC3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3023690"/>
              </p:ext>
            </p:extLst>
          </p:nvPr>
        </p:nvGraphicFramePr>
        <p:xfrm>
          <a:off x="2452013" y="4216455"/>
          <a:ext cx="5018138" cy="224719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8788">
                  <a:extLst>
                    <a:ext uri="{9D8B030D-6E8A-4147-A177-3AD203B41FA5}">
                      <a16:colId xmlns:a16="http://schemas.microsoft.com/office/drawing/2014/main" val="3897099444"/>
                    </a:ext>
                  </a:extLst>
                </a:gridCol>
                <a:gridCol w="780715">
                  <a:extLst>
                    <a:ext uri="{9D8B030D-6E8A-4147-A177-3AD203B41FA5}">
                      <a16:colId xmlns:a16="http://schemas.microsoft.com/office/drawing/2014/main" val="2865291727"/>
                    </a:ext>
                  </a:extLst>
                </a:gridCol>
                <a:gridCol w="1824262">
                  <a:extLst>
                    <a:ext uri="{9D8B030D-6E8A-4147-A177-3AD203B41FA5}">
                      <a16:colId xmlns:a16="http://schemas.microsoft.com/office/drawing/2014/main" val="4030251947"/>
                    </a:ext>
                  </a:extLst>
                </a:gridCol>
                <a:gridCol w="542261">
                  <a:extLst>
                    <a:ext uri="{9D8B030D-6E8A-4147-A177-3AD203B41FA5}">
                      <a16:colId xmlns:a16="http://schemas.microsoft.com/office/drawing/2014/main" val="2929492398"/>
                    </a:ext>
                  </a:extLst>
                </a:gridCol>
                <a:gridCol w="1212112">
                  <a:extLst>
                    <a:ext uri="{9D8B030D-6E8A-4147-A177-3AD203B41FA5}">
                      <a16:colId xmlns:a16="http://schemas.microsoft.com/office/drawing/2014/main" val="3518867729"/>
                    </a:ext>
                  </a:extLst>
                </a:gridCol>
              </a:tblGrid>
              <a:tr h="359973"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 dirty="0">
                          <a:solidFill>
                            <a:schemeClr val="tx1"/>
                          </a:solidFill>
                          <a:effectLst/>
                        </a:rPr>
                        <a:t>Subgroup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 dirty="0">
                          <a:solidFill>
                            <a:schemeClr val="tx1"/>
                          </a:solidFill>
                          <a:effectLst/>
                        </a:rPr>
                        <a:t>Primer Name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 dirty="0">
                          <a:solidFill>
                            <a:schemeClr val="tx1"/>
                          </a:solidFill>
                          <a:effectLst/>
                        </a:rPr>
                        <a:t>Sequence 5’-3’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Tm (</a:t>
                      </a:r>
                      <a:r>
                        <a:rPr lang="en-US" sz="900" baseline="30000" dirty="0">
                          <a:solidFill>
                            <a:schemeClr val="tx1"/>
                          </a:solidFill>
                          <a:effectLst/>
                        </a:rPr>
                        <a:t>°</a:t>
                      </a: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C)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Expected Product size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1540564"/>
                  </a:ext>
                </a:extLst>
              </a:tr>
              <a:tr h="0">
                <a:tc rowSpan="4"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>
                          <a:solidFill>
                            <a:schemeClr val="tx1"/>
                          </a:solidFill>
                          <a:effectLst/>
                        </a:rPr>
                        <a:t>SI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 dirty="0">
                          <a:solidFill>
                            <a:schemeClr val="tx1"/>
                          </a:solidFill>
                          <a:effectLst/>
                        </a:rPr>
                        <a:t>P5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 dirty="0">
                          <a:solidFill>
                            <a:schemeClr val="tx1"/>
                          </a:solidFill>
                          <a:effectLst/>
                        </a:rPr>
                        <a:t>GCGTTTGATGCTGTAGTTTG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56.0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4"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P5 + P6 = 1826 bp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P5 + P8 = 1005 bp</a:t>
                      </a:r>
                    </a:p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P7 + P6 = 904 bp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768580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>
                          <a:solidFill>
                            <a:schemeClr val="tx1"/>
                          </a:solidFill>
                          <a:effectLst/>
                        </a:rPr>
                        <a:t>P6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CAATCTGCGAGCCTTATTCA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55.9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587456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>
                          <a:solidFill>
                            <a:schemeClr val="tx1"/>
                          </a:solidFill>
                          <a:effectLst/>
                        </a:rPr>
                        <a:t>P7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ATCAGACAGCGGGGAATG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56.7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3475651"/>
                  </a:ext>
                </a:extLst>
              </a:tr>
              <a:tr h="91580"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>
                          <a:solidFill>
                            <a:schemeClr val="tx1"/>
                          </a:solidFill>
                          <a:effectLst/>
                        </a:rPr>
                        <a:t>P8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GGTGTGGCAAAGATCTTCA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55.4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29970951"/>
                  </a:ext>
                </a:extLst>
              </a:tr>
              <a:tr h="0">
                <a:tc rowSpan="4"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 dirty="0">
                          <a:solidFill>
                            <a:schemeClr val="tx1"/>
                          </a:solidFill>
                          <a:effectLst/>
                        </a:rPr>
                        <a:t>SII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>
                          <a:solidFill>
                            <a:schemeClr val="tx1"/>
                          </a:solidFill>
                          <a:effectLst/>
                        </a:rPr>
                        <a:t>P1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CTGTATGGATGATGTAGTCCG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55.4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4"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P1 + P2 = 1827 bp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P1 + P4 = 1006 bp</a:t>
                      </a:r>
                    </a:p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P3 + P2 = 904 bp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757556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>
                          <a:solidFill>
                            <a:schemeClr val="tx1"/>
                          </a:solidFill>
                          <a:effectLst/>
                        </a:rPr>
                        <a:t>P2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CAACTTGCGAGCCTTATTCA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56.4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553102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>
                          <a:solidFill>
                            <a:schemeClr val="tx1"/>
                          </a:solidFill>
                          <a:effectLst/>
                        </a:rPr>
                        <a:t>P3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ATCAGACTGCGGGGAATG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56.7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6075932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NZ" sz="900">
                          <a:solidFill>
                            <a:schemeClr val="tx1"/>
                          </a:solidFill>
                          <a:effectLst/>
                        </a:rPr>
                        <a:t>P4</a:t>
                      </a:r>
                      <a:endParaRPr lang="en-NZ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TGTGTGGCAAAGATCTTCG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269875" indent="-269875" algn="ctr">
                        <a:lnSpc>
                          <a:spcPct val="200000"/>
                        </a:lnSpc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55.9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88342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434740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4ACBD1D2-733F-E5E2-462D-135EB1E5A073}"/>
              </a:ext>
            </a:extLst>
          </p:cNvPr>
          <p:cNvGrpSpPr/>
          <p:nvPr/>
        </p:nvGrpSpPr>
        <p:grpSpPr>
          <a:xfrm>
            <a:off x="649294" y="80010"/>
            <a:ext cx="10893412" cy="6275070"/>
            <a:chOff x="0" y="44433"/>
            <a:chExt cx="11004524" cy="6717874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2644E5EC-41E1-CA21-61EB-1987A4BC21EA}"/>
                </a:ext>
              </a:extLst>
            </p:cNvPr>
            <p:cNvGrpSpPr/>
            <p:nvPr/>
          </p:nvGrpSpPr>
          <p:grpSpPr>
            <a:xfrm>
              <a:off x="0" y="44433"/>
              <a:ext cx="11004524" cy="6717874"/>
              <a:chOff x="0" y="44433"/>
              <a:chExt cx="11004524" cy="6717874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82C344CB-1960-5FF9-A170-1EB9D00E73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93937"/>
              <a:stretch/>
            </p:blipFill>
            <p:spPr>
              <a:xfrm>
                <a:off x="0" y="44434"/>
                <a:ext cx="733647" cy="6717873"/>
              </a:xfrm>
              <a:prstGeom prst="rect">
                <a:avLst/>
              </a:prstGeom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9B49C1AB-1D73-0A25-2717-77DB02702E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5115"/>
              <a:stretch/>
            </p:blipFill>
            <p:spPr>
              <a:xfrm>
                <a:off x="733647" y="44433"/>
                <a:ext cx="10270877" cy="6717873"/>
              </a:xfrm>
              <a:prstGeom prst="rect">
                <a:avLst/>
              </a:prstGeom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A046C97-C0F7-512C-D4A9-C1120C0DC2C1}"/>
                </a:ext>
              </a:extLst>
            </p:cNvPr>
            <p:cNvSpPr txBox="1"/>
            <p:nvPr/>
          </p:nvSpPr>
          <p:spPr>
            <a:xfrm>
              <a:off x="5326398" y="2199849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2000" dirty="0">
                  <a:solidFill>
                    <a:srgbClr val="C00000"/>
                  </a:solidFill>
                </a:rPr>
                <a:t>*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8D44571-5A40-031F-D99A-16C05E090309}"/>
                </a:ext>
              </a:extLst>
            </p:cNvPr>
            <p:cNvSpPr txBox="1"/>
            <p:nvPr/>
          </p:nvSpPr>
          <p:spPr>
            <a:xfrm>
              <a:off x="5496369" y="2199849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2000" dirty="0">
                  <a:solidFill>
                    <a:srgbClr val="C00000"/>
                  </a:solidFill>
                </a:rPr>
                <a:t>*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E72C95A1-CD1C-54D2-B423-A1FB5CA789F8}"/>
              </a:ext>
            </a:extLst>
          </p:cNvPr>
          <p:cNvSpPr txBox="1"/>
          <p:nvPr/>
        </p:nvSpPr>
        <p:spPr>
          <a:xfrm>
            <a:off x="547153" y="6254769"/>
            <a:ext cx="113187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400" b="1" dirty="0">
                <a:latin typeface="Palatino Linotype" panose="02040502050505030304" pitchFamily="18" charset="0"/>
              </a:rPr>
              <a:t>Figure S2. </a:t>
            </a:r>
            <a:r>
              <a:rPr lang="en-NZ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Multiple sequence alignment of the pre-fusion glycoprotein amino acid sequences. The amino acids indicated by the red asterisks at positions 269 and 272 correspond to the aa positions 244 and 247 in the post-fusion protein. </a:t>
            </a:r>
          </a:p>
        </p:txBody>
      </p:sp>
    </p:spTree>
    <p:extLst>
      <p:ext uri="{BB962C8B-B14F-4D97-AF65-F5344CB8AC3E}">
        <p14:creationId xmlns:p14="http://schemas.microsoft.com/office/powerpoint/2010/main" val="2288281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cb59dfef-b972-42b7-b93c-06b0a9272df1">
      <Terms xmlns="http://schemas.microsoft.com/office/infopath/2007/PartnerControls"/>
    </lcf76f155ced4ddcb4097134ff3c332f>
    <TaxCatchAll xmlns="ea159869-2683-4f06-a972-ca9ad1f16645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7426713D4476443A1F999FB23242B4E" ma:contentTypeVersion="12" ma:contentTypeDescription="Create a new document." ma:contentTypeScope="" ma:versionID="26f765867dae0ce116dc6e79aaa17af9">
  <xsd:schema xmlns:xsd="http://www.w3.org/2001/XMLSchema" xmlns:xs="http://www.w3.org/2001/XMLSchema" xmlns:p="http://schemas.microsoft.com/office/2006/metadata/properties" xmlns:ns2="cb59dfef-b972-42b7-b93c-06b0a9272df1" xmlns:ns3="ea159869-2683-4f06-a972-ca9ad1f16645" targetNamespace="http://schemas.microsoft.com/office/2006/metadata/properties" ma:root="true" ma:fieldsID="254d6d682559f841b4c35e8783c0ffa3" ns2:_="" ns3:_="">
    <xsd:import namespace="cb59dfef-b972-42b7-b93c-06b0a9272df1"/>
    <xsd:import namespace="ea159869-2683-4f06-a972-ca9ad1f16645"/>
    <xsd:element name="properties">
      <xsd:complexType>
        <xsd:sequence>
          <xsd:element name="documentManagement">
            <xsd:complexType>
              <xsd:all>
                <xsd:element ref="ns2:lcf76f155ced4ddcb4097134ff3c332f" minOccurs="0"/>
                <xsd:element ref="ns3:TaxCatchAll" minOccurs="0"/>
                <xsd:element ref="ns2:MediaServiceMetadata" minOccurs="0"/>
                <xsd:element ref="ns2:MediaServiceFastMetadata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b59dfef-b972-42b7-b93c-06b0a9272df1" elementFormDefault="qualified">
    <xsd:import namespace="http://schemas.microsoft.com/office/2006/documentManagement/types"/>
    <xsd:import namespace="http://schemas.microsoft.com/office/infopath/2007/PartnerControls"/>
    <xsd:element name="lcf76f155ced4ddcb4097134ff3c332f" ma:index="9" nillable="true" ma:taxonomy="true" ma:internalName="lcf76f155ced4ddcb4097134ff3c332f" ma:taxonomyFieldName="MediaServiceImageTags" ma:displayName="Image Tags" ma:readOnly="false" ma:fieldId="{5cf76f15-5ced-4ddc-b409-7134ff3c332f}" ma:taxonomyMulti="true" ma:sspId="490d87cd-ec7d-4fd9-8d9f-27dff7dbbc74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a159869-2683-4f06-a972-ca9ad1f16645" elementFormDefault="qualified">
    <xsd:import namespace="http://schemas.microsoft.com/office/2006/documentManagement/types"/>
    <xsd:import namespace="http://schemas.microsoft.com/office/infopath/2007/PartnerControls"/>
    <xsd:element name="TaxCatchAll" ma:index="10" nillable="true" ma:displayName="Taxonomy Catch All Column" ma:hidden="true" ma:list="{8728dc4a-5095-43ea-a940-fdb7b607070a}" ma:internalName="TaxCatchAll" ma:showField="CatchAllData" ma:web="ea159869-2683-4f06-a972-ca9ad1f16645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B2F2294F-DD8E-4283-AA03-72ACAE2935F8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cb59dfef-b972-42b7-b93c-06b0a9272df1"/>
    <ds:schemaRef ds:uri="http://purl.org/dc/elements/1.1/"/>
    <ds:schemaRef ds:uri="http://schemas.microsoft.com/office/2006/metadata/properties"/>
    <ds:schemaRef ds:uri="ea159869-2683-4f06-a972-ca9ad1f16645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F74E8D2E-688D-40A3-AFD1-C3B7AD6B2F0F}"/>
</file>

<file path=customXml/itemProps3.xml><?xml version="1.0" encoding="utf-8"?>
<ds:datastoreItem xmlns:ds="http://schemas.openxmlformats.org/officeDocument/2006/customXml" ds:itemID="{D0FCEEC6-BDB7-4D07-9ADD-0C57A90651F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627</TotalTime>
  <Words>275</Words>
  <Application>Microsoft Office PowerPoint</Application>
  <PresentationFormat>Widescreen</PresentationFormat>
  <Paragraphs>9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leen Higgins</dc:creator>
  <cp:lastModifiedBy>Gardette Valmonte</cp:lastModifiedBy>
  <cp:revision>7</cp:revision>
  <dcterms:created xsi:type="dcterms:W3CDTF">2022-06-12T00:20:44Z</dcterms:created>
  <dcterms:modified xsi:type="dcterms:W3CDTF">2022-06-18T05:53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7426713D4476443A1F999FB23242B4E</vt:lpwstr>
  </property>
  <property fmtid="{D5CDD505-2E9C-101B-9397-08002B2CF9AE}" pid="3" name="MediaServiceImageTags">
    <vt:lpwstr/>
  </property>
</Properties>
</file>